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93" d="100"/>
          <a:sy n="93" d="100"/>
        </p:scale>
        <p:origin x="274" y="-33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7AFB6C-2300-79DB-350C-5626BA41A31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CFD4EEA-2A65-DD37-0F9A-F1EA00E201D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0FCA17-A163-B586-9336-BD7800CA16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EC8F96-4835-44C2-8E11-F0381095CB77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640263-F518-79ED-A7F9-0F77AC1302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FA4EBD-87EA-F61C-5A52-30EB2F6B4F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24E3A6-92E9-464F-BD09-316634FFBB1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0680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577913-3088-7F9A-9872-C2A4F766B9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138CF99-2F51-4713-0A72-EE236E6C417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0C80DC-1847-280C-E173-29D1529D28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EC8F96-4835-44C2-8E11-F0381095CB77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44610E-C581-38AA-6659-40AAD5B986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D0BF92-A964-97ED-69D7-D4209D37C3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24E3A6-92E9-464F-BD09-316634FFBB1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4636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198BEB3-CD37-0D06-FC19-073ACA9DA9C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7FB772D-BA45-7E43-8744-E641DBD5610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E6E452-7D10-733B-B455-6B60E90349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EC8F96-4835-44C2-8E11-F0381095CB77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5DA3C9-626A-691C-F392-69D4C2A3DF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1AEFAC-F525-9EBF-49FC-BEDEC3B86D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24E3A6-92E9-464F-BD09-316634FFBB1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01097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9D16B0-A6DD-254B-187D-30CC4C0E9E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E97B5DD-AD51-053A-9039-23CC38C87EA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A90E84-9C64-99CC-0B17-D930F90CB2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EC8F96-4835-44C2-8E11-F0381095CB77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A5FB56-83B7-55E9-A2FA-39F0D52A39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D33752-B974-EBD6-6C11-C98182253F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24E3A6-92E9-464F-BD09-316634FFBB1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4028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568E29-91C5-C9FF-A2BB-75A6BB5644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1AA8344-B4D0-7CF3-4CD5-91698F1D81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3CCC9F-8B1A-07DF-1808-41DC154E4A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EC8F96-4835-44C2-8E11-F0381095CB77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A5B8A8-26DE-57BD-7525-9A5CC33788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67E09F-E81F-728E-E6CA-F7EF2E99C8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24E3A6-92E9-464F-BD09-316634FFBB1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53887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068A49-F038-F3A7-E747-CE21B310FD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CD2A827-F64F-5F20-966B-A35875E28AF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F205C06-8F4F-0009-2DF4-C4ECC942E10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CC9CBB-C4B2-12F0-3BF9-AF4E08CDF6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EC8F96-4835-44C2-8E11-F0381095CB77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6B5DFF1-6994-3126-8B76-E72C7715A0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E4F88B1-AB24-039C-D0AF-980957A506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24E3A6-92E9-464F-BD09-316634FFBB1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75443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B5B3DB-9952-898E-150E-D728796EE0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E2ED8FE-777E-C24F-FD05-A4CF683750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FC85AA2-B103-A366-6542-EB57175339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1A2F4B2-82AD-C418-94B5-C66347C0255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59C4C34-5CAF-3FED-8A9F-A640B5CC1BB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E3A69A5-C843-48DA-9172-4A139B3CBB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EC8F96-4835-44C2-8E11-F0381095CB77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3277F1C-990A-4DD2-15F7-0A7D5E004A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FF17A3E-DFDC-9BAC-AB4A-092FD81E7F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24E3A6-92E9-464F-BD09-316634FFBB1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98535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A39430-6479-DB53-FF21-29ABC146E0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EB3DBE2-5601-ECDC-984B-998CB003F3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EC8F96-4835-44C2-8E11-F0381095CB77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08FB43E-4FDC-01A2-EF43-3AEE605490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462D624-E885-32DE-971B-0542C010FD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24E3A6-92E9-464F-BD09-316634FFBB1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93918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1CA4936-2080-8F37-2A5A-579C2C3F15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EC8F96-4835-44C2-8E11-F0381095CB77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9FFC9F9-05FA-2899-9FD8-F475107A9E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A8A5867-FB96-DBA6-A6C5-C68E79889E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24E3A6-92E9-464F-BD09-316634FFBB1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84089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E7D7F1-A85B-62E2-C51A-C40D24C5CC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E8FCDEC-934A-F06A-5C1B-9F087824652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EC9EAC7-EDF5-7734-38F4-AE747E5BC4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1D80F8C-2794-9927-CF01-39661FD910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EC8F96-4835-44C2-8E11-F0381095CB77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DA4BB84-55A5-A3E2-D25E-8B29381579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8981537-27A4-2A48-E325-A692D4DACF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24E3A6-92E9-464F-BD09-316634FFBB1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17439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5CD8A3-328F-4BAD-F049-E2E303A2B4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2D8ED12-2F45-4899-9FE0-3A834F4D92E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E175A69-D7F4-C620-B7D9-2C96813857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C0540AD-6A55-C6BE-018B-EB5C05CB4B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EC8F96-4835-44C2-8E11-F0381095CB77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367DA39-89CF-6CC6-3638-87EBE627E6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48A340B-B48D-8603-FCDA-78A775BDE5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24E3A6-92E9-464F-BD09-316634FFBB1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57158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37195CB-26AE-9794-266E-6192D25EA7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221FD59-61E8-FB12-3B47-F26F86C07B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D6F733-E68A-C4DE-CC15-76354E04CB9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8EC8F96-4835-44C2-8E11-F0381095CB77}" type="datetimeFigureOut">
              <a:rPr lang="en-GB" smtClean="0"/>
              <a:t>01/09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9A4243-3FED-E4AF-E171-9225D13A7A4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5234DD-3BF8-CEDC-7BAE-3FE512C2AFB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224E3A6-92E9-464F-BD09-316634FFBB1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32667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tif"/><Relationship Id="rId4" Type="http://schemas.openxmlformats.org/officeDocument/2006/relationships/image" Target="../media/image6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black and white image of a grid&#10;&#10;Description automatically generated">
            <a:extLst>
              <a:ext uri="{FF2B5EF4-FFF2-40B4-BE49-F238E27FC236}">
                <a16:creationId xmlns:a16="http://schemas.microsoft.com/office/drawing/2014/main" id="{BA8C3F07-210A-AB60-40DF-36364450C292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5" t="-2435" r="-40" b="-1243"/>
          <a:stretch/>
        </p:blipFill>
        <p:spPr>
          <a:xfrm>
            <a:off x="5583677" y="541988"/>
            <a:ext cx="4202349" cy="1682885"/>
          </a:xfrm>
          <a:prstGeom prst="rect">
            <a:avLst/>
          </a:prstGeom>
          <a:ln>
            <a:noFill/>
          </a:ln>
        </p:spPr>
      </p:pic>
      <p:pic>
        <p:nvPicPr>
          <p:cNvPr id="5" name="Picture 4" descr="A black line on a white background&#10;&#10;Description automatically generated">
            <a:extLst>
              <a:ext uri="{FF2B5EF4-FFF2-40B4-BE49-F238E27FC236}">
                <a16:creationId xmlns:a16="http://schemas.microsoft.com/office/drawing/2014/main" id="{0BE045C1-BABB-C3D3-E0CB-24A9822B5FA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23" t="-2420" r="-285" b="-649"/>
          <a:stretch/>
        </p:blipFill>
        <p:spPr>
          <a:xfrm>
            <a:off x="5583677" y="2357687"/>
            <a:ext cx="4202348" cy="1710991"/>
          </a:xfrm>
          <a:prstGeom prst="rect">
            <a:avLst/>
          </a:prstGeom>
          <a:ln w="6350">
            <a:noFill/>
          </a:ln>
        </p:spPr>
      </p:pic>
      <p:pic>
        <p:nvPicPr>
          <p:cNvPr id="6" name="Picture 5" descr="A close-up of a heart&#10;&#10;Description automatically generated">
            <a:extLst>
              <a:ext uri="{FF2B5EF4-FFF2-40B4-BE49-F238E27FC236}">
                <a16:creationId xmlns:a16="http://schemas.microsoft.com/office/drawing/2014/main" id="{44536596-2D09-3B98-7D04-BD5A95FDD427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8" t="-630" r="-1694" b="579"/>
          <a:stretch/>
        </p:blipFill>
        <p:spPr>
          <a:xfrm>
            <a:off x="229051" y="2357687"/>
            <a:ext cx="4810779" cy="1687113"/>
          </a:xfrm>
          <a:prstGeom prst="rect">
            <a:avLst/>
          </a:prstGeom>
          <a:ln>
            <a:noFill/>
          </a:ln>
        </p:spPr>
      </p:pic>
      <p:pic>
        <p:nvPicPr>
          <p:cNvPr id="7" name="Picture 6" descr="A close-up of a dna&#10;&#10;Description automatically generated">
            <a:extLst>
              <a:ext uri="{FF2B5EF4-FFF2-40B4-BE49-F238E27FC236}">
                <a16:creationId xmlns:a16="http://schemas.microsoft.com/office/drawing/2014/main" id="{3F28C65B-DDC6-757D-DEF2-89FF9AEC574D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024" t="-197" r="-322" b="-111"/>
          <a:stretch/>
        </p:blipFill>
        <p:spPr>
          <a:xfrm>
            <a:off x="229051" y="541988"/>
            <a:ext cx="4883285" cy="1682885"/>
          </a:xfrm>
          <a:prstGeom prst="rect">
            <a:avLst/>
          </a:prstGeom>
          <a:ln>
            <a:noFill/>
          </a:ln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BCA7CAFF-BA47-D494-F630-9B37589E8585}"/>
              </a:ext>
            </a:extLst>
          </p:cNvPr>
          <p:cNvSpPr txBox="1"/>
          <p:nvPr/>
        </p:nvSpPr>
        <p:spPr>
          <a:xfrm>
            <a:off x="0" y="77822"/>
            <a:ext cx="21022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HT29_biological replicate_n1</a:t>
            </a:r>
          </a:p>
        </p:txBody>
      </p:sp>
      <p:pic>
        <p:nvPicPr>
          <p:cNvPr id="10" name="Picture 9" descr="A close up of a white background&#10;&#10;Description automatically generated">
            <a:extLst>
              <a:ext uri="{FF2B5EF4-FFF2-40B4-BE49-F238E27FC236}">
                <a16:creationId xmlns:a16="http://schemas.microsoft.com/office/drawing/2014/main" id="{E5F04B18-F758-C36B-FFD0-C01BD6B0459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39844" y="4332501"/>
            <a:ext cx="3319653" cy="2290794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BC8656F0-D0D6-FFC1-1A70-2DC9921A2B55}"/>
              </a:ext>
            </a:extLst>
          </p:cNvPr>
          <p:cNvSpPr/>
          <p:nvPr/>
        </p:nvSpPr>
        <p:spPr>
          <a:xfrm>
            <a:off x="6107151" y="1231545"/>
            <a:ext cx="1381125" cy="15240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360E5531-FFC8-CDB9-DAAB-884B89E9B4DD}"/>
              </a:ext>
            </a:extLst>
          </p:cNvPr>
          <p:cNvSpPr/>
          <p:nvPr/>
        </p:nvSpPr>
        <p:spPr>
          <a:xfrm>
            <a:off x="6162907" y="3336266"/>
            <a:ext cx="1381125" cy="15240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0ECE471B-6E66-29B8-BC75-B36115C9D4AA}"/>
              </a:ext>
            </a:extLst>
          </p:cNvPr>
          <p:cNvSpPr/>
          <p:nvPr/>
        </p:nvSpPr>
        <p:spPr>
          <a:xfrm>
            <a:off x="5997962" y="4859097"/>
            <a:ext cx="1099351" cy="168824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59F8E5B-4D40-253F-E843-F2B4C5D39A99}"/>
              </a:ext>
            </a:extLst>
          </p:cNvPr>
          <p:cNvSpPr txBox="1"/>
          <p:nvPr/>
        </p:nvSpPr>
        <p:spPr>
          <a:xfrm>
            <a:off x="8327729" y="3273966"/>
            <a:ext cx="654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solidFill>
                  <a:srgbClr val="FF0000"/>
                </a:solidFill>
              </a:rPr>
              <a:t>β</a:t>
            </a:r>
            <a:r>
              <a:rPr lang="en-GB" sz="1200" dirty="0">
                <a:solidFill>
                  <a:srgbClr val="FF0000"/>
                </a:solidFill>
              </a:rPr>
              <a:t>-actin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502CE0D-F035-04EF-9ACB-786FF3FDB7E9}"/>
              </a:ext>
            </a:extLst>
          </p:cNvPr>
          <p:cNvSpPr txBox="1"/>
          <p:nvPr/>
        </p:nvSpPr>
        <p:spPr>
          <a:xfrm>
            <a:off x="7662273" y="4805009"/>
            <a:ext cx="5389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PERK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8163BCF-17DD-D503-73AD-46E752CA4044}"/>
              </a:ext>
            </a:extLst>
          </p:cNvPr>
          <p:cNvSpPr txBox="1"/>
          <p:nvPr/>
        </p:nvSpPr>
        <p:spPr>
          <a:xfrm>
            <a:off x="8223781" y="1169245"/>
            <a:ext cx="6495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SUSD6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01F1A671-3F80-0032-6D4C-54A61CA3F16B}"/>
              </a:ext>
            </a:extLst>
          </p:cNvPr>
          <p:cNvSpPr/>
          <p:nvPr/>
        </p:nvSpPr>
        <p:spPr>
          <a:xfrm>
            <a:off x="584940" y="1079640"/>
            <a:ext cx="1311593" cy="22291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457591C-2FA3-413B-FBDD-5B0FB462244C}"/>
              </a:ext>
            </a:extLst>
          </p:cNvPr>
          <p:cNvSpPr txBox="1"/>
          <p:nvPr/>
        </p:nvSpPr>
        <p:spPr>
          <a:xfrm>
            <a:off x="1051121" y="830636"/>
            <a:ext cx="5389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PERK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44331A8E-0614-D7EE-5F4A-A8466F77F795}"/>
              </a:ext>
            </a:extLst>
          </p:cNvPr>
          <p:cNvSpPr/>
          <p:nvPr/>
        </p:nvSpPr>
        <p:spPr>
          <a:xfrm>
            <a:off x="478260" y="3608490"/>
            <a:ext cx="1418273" cy="22531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C882B97-0B8E-7CDF-EE7F-EDD6A83D98AD}"/>
              </a:ext>
            </a:extLst>
          </p:cNvPr>
          <p:cNvSpPr txBox="1"/>
          <p:nvPr/>
        </p:nvSpPr>
        <p:spPr>
          <a:xfrm>
            <a:off x="1094761" y="3800802"/>
            <a:ext cx="8322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TMEM127</a:t>
            </a:r>
          </a:p>
        </p:txBody>
      </p:sp>
      <p:pic>
        <p:nvPicPr>
          <p:cNvPr id="23" name="Picture 22" descr="A black line on a white background&#10;&#10;Description automatically generated">
            <a:extLst>
              <a:ext uri="{FF2B5EF4-FFF2-40B4-BE49-F238E27FC236}">
                <a16:creationId xmlns:a16="http://schemas.microsoft.com/office/drawing/2014/main" id="{AE23EF11-A9D1-7974-9D20-EEAC74E9F4EA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6473" y="4201980"/>
            <a:ext cx="4810778" cy="2504800"/>
          </a:xfrm>
          <a:prstGeom prst="rect">
            <a:avLst/>
          </a:prstGeom>
        </p:spPr>
      </p:pic>
      <p:sp>
        <p:nvSpPr>
          <p:cNvPr id="24" name="Rectangle 23">
            <a:extLst>
              <a:ext uri="{FF2B5EF4-FFF2-40B4-BE49-F238E27FC236}">
                <a16:creationId xmlns:a16="http://schemas.microsoft.com/office/drawing/2014/main" id="{6B43A68F-43E9-00C9-1382-A026A9148405}"/>
              </a:ext>
            </a:extLst>
          </p:cNvPr>
          <p:cNvSpPr/>
          <p:nvPr/>
        </p:nvSpPr>
        <p:spPr>
          <a:xfrm>
            <a:off x="584940" y="5870522"/>
            <a:ext cx="1418273" cy="22531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AADFD39-8533-8D93-0B49-ACB7C481A710}"/>
              </a:ext>
            </a:extLst>
          </p:cNvPr>
          <p:cNvSpPr txBox="1"/>
          <p:nvPr/>
        </p:nvSpPr>
        <p:spPr>
          <a:xfrm>
            <a:off x="1320586" y="6177512"/>
            <a:ext cx="654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solidFill>
                  <a:srgbClr val="FF0000"/>
                </a:solidFill>
              </a:rPr>
              <a:t>β</a:t>
            </a:r>
            <a:r>
              <a:rPr lang="en-GB" sz="1200" dirty="0">
                <a:solidFill>
                  <a:srgbClr val="FF0000"/>
                </a:solidFill>
              </a:rPr>
              <a:t>-actin</a:t>
            </a:r>
          </a:p>
        </p:txBody>
      </p:sp>
    </p:spTree>
    <p:extLst>
      <p:ext uri="{BB962C8B-B14F-4D97-AF65-F5344CB8AC3E}">
        <p14:creationId xmlns:p14="http://schemas.microsoft.com/office/powerpoint/2010/main" val="37055340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9330463-29F4-3D3B-581A-4AFFD3A78EA3}"/>
              </a:ext>
            </a:extLst>
          </p:cNvPr>
          <p:cNvSpPr txBox="1"/>
          <p:nvPr/>
        </p:nvSpPr>
        <p:spPr>
          <a:xfrm>
            <a:off x="0" y="77822"/>
            <a:ext cx="21022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HT29_biological replicate_n2</a:t>
            </a:r>
          </a:p>
        </p:txBody>
      </p:sp>
      <p:pic>
        <p:nvPicPr>
          <p:cNvPr id="5" name="Picture 4" descr="A close-up of a heart&#10;&#10;Description automatically generated">
            <a:extLst>
              <a:ext uri="{FF2B5EF4-FFF2-40B4-BE49-F238E27FC236}">
                <a16:creationId xmlns:a16="http://schemas.microsoft.com/office/drawing/2014/main" id="{0EE14DF3-1B56-7042-77EE-46759007DD7D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8" t="-630" r="-1694" b="579"/>
          <a:stretch/>
        </p:blipFill>
        <p:spPr>
          <a:xfrm>
            <a:off x="229051" y="2357687"/>
            <a:ext cx="4810779" cy="1687113"/>
          </a:xfrm>
          <a:prstGeom prst="rect">
            <a:avLst/>
          </a:prstGeom>
          <a:ln>
            <a:noFill/>
          </a:ln>
        </p:spPr>
      </p:pic>
      <p:pic>
        <p:nvPicPr>
          <p:cNvPr id="6" name="Picture 5" descr="A close-up of a dna&#10;&#10;Description automatically generated">
            <a:extLst>
              <a:ext uri="{FF2B5EF4-FFF2-40B4-BE49-F238E27FC236}">
                <a16:creationId xmlns:a16="http://schemas.microsoft.com/office/drawing/2014/main" id="{6CD588D8-D5CD-6C78-B245-B9C5D6F7F7D7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024" t="-197" r="-322" b="-111"/>
          <a:stretch/>
        </p:blipFill>
        <p:spPr>
          <a:xfrm>
            <a:off x="206473" y="531127"/>
            <a:ext cx="4883285" cy="1682885"/>
          </a:xfrm>
          <a:prstGeom prst="rect">
            <a:avLst/>
          </a:prstGeom>
          <a:ln>
            <a:noFill/>
          </a:ln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8794E181-3382-DE83-89CA-43A94A8887BB}"/>
              </a:ext>
            </a:extLst>
          </p:cNvPr>
          <p:cNvSpPr/>
          <p:nvPr/>
        </p:nvSpPr>
        <p:spPr>
          <a:xfrm>
            <a:off x="2275194" y="1071698"/>
            <a:ext cx="1437824" cy="22291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84FA543-E34E-6868-C079-7FDFCBCC5FAE}"/>
              </a:ext>
            </a:extLst>
          </p:cNvPr>
          <p:cNvSpPr txBox="1"/>
          <p:nvPr/>
        </p:nvSpPr>
        <p:spPr>
          <a:xfrm>
            <a:off x="3804561" y="1045669"/>
            <a:ext cx="5907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PERK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93199689-BA6D-2C7D-F30E-FCE0736F9867}"/>
              </a:ext>
            </a:extLst>
          </p:cNvPr>
          <p:cNvSpPr/>
          <p:nvPr/>
        </p:nvSpPr>
        <p:spPr>
          <a:xfrm>
            <a:off x="2203151" y="3585122"/>
            <a:ext cx="1418273" cy="22531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DF7295A-96C5-A61D-AB27-BC8DEA4ACD54}"/>
              </a:ext>
            </a:extLst>
          </p:cNvPr>
          <p:cNvSpPr txBox="1"/>
          <p:nvPr/>
        </p:nvSpPr>
        <p:spPr>
          <a:xfrm>
            <a:off x="3683820" y="3531133"/>
            <a:ext cx="8322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TMEM127</a:t>
            </a:r>
          </a:p>
        </p:txBody>
      </p:sp>
      <p:pic>
        <p:nvPicPr>
          <p:cNvPr id="11" name="Picture 10" descr="A black line on a white background&#10;&#10;Description automatically generated">
            <a:extLst>
              <a:ext uri="{FF2B5EF4-FFF2-40B4-BE49-F238E27FC236}">
                <a16:creationId xmlns:a16="http://schemas.microsoft.com/office/drawing/2014/main" id="{FAAAAE9A-3755-D01A-30E8-BE9F58A9262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6473" y="4201980"/>
            <a:ext cx="4810778" cy="2504800"/>
          </a:xfrm>
          <a:prstGeom prst="rect">
            <a:avLst/>
          </a:prstGeom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id="{4612C24C-6C9F-D795-E021-48853669CCE9}"/>
              </a:ext>
            </a:extLst>
          </p:cNvPr>
          <p:cNvSpPr/>
          <p:nvPr/>
        </p:nvSpPr>
        <p:spPr>
          <a:xfrm>
            <a:off x="2275194" y="5781003"/>
            <a:ext cx="1529367" cy="242711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8367E7B-82FE-B56E-8952-33B57DF4AD09}"/>
              </a:ext>
            </a:extLst>
          </p:cNvPr>
          <p:cNvSpPr txBox="1"/>
          <p:nvPr/>
        </p:nvSpPr>
        <p:spPr>
          <a:xfrm>
            <a:off x="3772787" y="5749906"/>
            <a:ext cx="654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solidFill>
                  <a:srgbClr val="FF0000"/>
                </a:solidFill>
              </a:rPr>
              <a:t>β</a:t>
            </a:r>
            <a:r>
              <a:rPr lang="en-GB" sz="1200" dirty="0">
                <a:solidFill>
                  <a:srgbClr val="FF0000"/>
                </a:solidFill>
              </a:rPr>
              <a:t>-actin</a:t>
            </a:r>
          </a:p>
        </p:txBody>
      </p:sp>
      <p:pic>
        <p:nvPicPr>
          <p:cNvPr id="15" name="Picture 14" descr="A close-up of a test&#10;&#10;Description automatically generated">
            <a:extLst>
              <a:ext uri="{FF2B5EF4-FFF2-40B4-BE49-F238E27FC236}">
                <a16:creationId xmlns:a16="http://schemas.microsoft.com/office/drawing/2014/main" id="{F0108869-3C01-4517-8E44-E81D1CA241B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81739" y="503901"/>
            <a:ext cx="4678283" cy="2925099"/>
          </a:xfrm>
          <a:prstGeom prst="rect">
            <a:avLst/>
          </a:prstGeom>
        </p:spPr>
      </p:pic>
      <p:sp>
        <p:nvSpPr>
          <p:cNvPr id="16" name="Rectangle 15">
            <a:extLst>
              <a:ext uri="{FF2B5EF4-FFF2-40B4-BE49-F238E27FC236}">
                <a16:creationId xmlns:a16="http://schemas.microsoft.com/office/drawing/2014/main" id="{A0577040-A3BB-628C-DEB7-7F59B94C54E0}"/>
              </a:ext>
            </a:extLst>
          </p:cNvPr>
          <p:cNvSpPr/>
          <p:nvPr/>
        </p:nvSpPr>
        <p:spPr>
          <a:xfrm>
            <a:off x="6403713" y="1511632"/>
            <a:ext cx="1381125" cy="15240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663EFCE-61FC-13A0-CF68-5991F2E465FF}"/>
              </a:ext>
            </a:extLst>
          </p:cNvPr>
          <p:cNvSpPr txBox="1"/>
          <p:nvPr/>
        </p:nvSpPr>
        <p:spPr>
          <a:xfrm>
            <a:off x="7784838" y="1449332"/>
            <a:ext cx="6495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>
                <a:solidFill>
                  <a:srgbClr val="FF0000"/>
                </a:solidFill>
              </a:rPr>
              <a:t>SUSD6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05EEA4C1-46B6-6E77-1FC3-9A7805804F65}"/>
              </a:ext>
            </a:extLst>
          </p:cNvPr>
          <p:cNvSpPr/>
          <p:nvPr/>
        </p:nvSpPr>
        <p:spPr>
          <a:xfrm>
            <a:off x="6341633" y="2124634"/>
            <a:ext cx="1453963" cy="200779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FA51BBC-0F85-D234-31CF-74018D4354AE}"/>
              </a:ext>
            </a:extLst>
          </p:cNvPr>
          <p:cNvSpPr txBox="1"/>
          <p:nvPr/>
        </p:nvSpPr>
        <p:spPr>
          <a:xfrm>
            <a:off x="7375647" y="2325413"/>
            <a:ext cx="6543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solidFill>
                  <a:srgbClr val="FF0000"/>
                </a:solidFill>
              </a:rPr>
              <a:t>β</a:t>
            </a:r>
            <a:r>
              <a:rPr lang="en-GB" sz="1200" dirty="0">
                <a:solidFill>
                  <a:srgbClr val="FF0000"/>
                </a:solidFill>
              </a:rPr>
              <a:t>-actin</a:t>
            </a:r>
          </a:p>
        </p:txBody>
      </p:sp>
    </p:spTree>
    <p:extLst>
      <p:ext uri="{BB962C8B-B14F-4D97-AF65-F5344CB8AC3E}">
        <p14:creationId xmlns:p14="http://schemas.microsoft.com/office/powerpoint/2010/main" val="34386220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</TotalTime>
  <Words>27</Words>
  <Application>Microsoft Office PowerPoint</Application>
  <PresentationFormat>Widescreen</PresentationFormat>
  <Paragraphs>1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ala Estephan</dc:creator>
  <cp:lastModifiedBy>Hala Estephan</cp:lastModifiedBy>
  <cp:revision>4</cp:revision>
  <dcterms:created xsi:type="dcterms:W3CDTF">2024-09-01T10:22:32Z</dcterms:created>
  <dcterms:modified xsi:type="dcterms:W3CDTF">2024-09-01T10:56:52Z</dcterms:modified>
</cp:coreProperties>
</file>